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4C83E-E34C-46B0-ADEB-0BD8E7C4E3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AD9EC7-4085-4BDD-B972-795DF46E02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40D21-8544-41FB-8DE1-1A71BC82B7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96B73-00FC-403A-8773-73605A2001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DE248-C52A-4598-9A0C-E0715E0123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F4983-7F36-4FC9-BA94-679B20FA6B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493A9-DE03-4BB6-8D01-2E780FEEB7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F7DF9-3E09-4EB2-8BBC-8250E10A71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18A0C-75E5-477A-B1D4-E6C92CC2B6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C8607-1D19-4314-B374-22FF20F22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4F59E-F814-4AB5-8154-C2EE969936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BA6BF-ADA3-49E5-BA54-D6BE5AD5B7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8F2E28-B03B-439E-9AAD-D34A62058A7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77920" y="15778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65120" y="31622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57200" y="6634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514440" y="31780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1154160" y="27702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853920" y="32623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344600" y="21528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rcRect l="0" t="0" r="35420" b="0"/>
          <a:stretch/>
        </p:blipFill>
        <p:spPr>
          <a:xfrm>
            <a:off x="914400" y="533520"/>
            <a:ext cx="5146560" cy="691488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685800" y="7623000"/>
            <a:ext cx="57913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7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condary structure of the LRRs of LgrA to LgrF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 amoebophi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of the human NOD3 protei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of a LRR-protei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gionella pneumophi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predicted by NNPREDICT, and of LgrE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of all repeats of Lgrs combined together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predicted by PREDATOR.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22:55Z</dcterms:created>
  <dc:creator>Gilbert Greub</dc:creator>
  <dc:description/>
  <dc:language>en-US</dc:language>
  <cp:lastModifiedBy>CA Roten</cp:lastModifiedBy>
  <dcterms:modified xsi:type="dcterms:W3CDTF">2007-11-14T16:06:53Z</dcterms:modified>
  <cp:revision>12</cp:revision>
  <dc:subject/>
  <dc:title>Présentation PowerPoint</dc:title>
</cp:coreProperties>
</file>